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410" r:id="rId2"/>
  </p:sldIdLst>
  <p:sldSz cx="6858000" cy="9906000" type="A4"/>
  <p:notesSz cx="9931400" cy="67945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10" userDrawn="1">
          <p15:clr>
            <a:srgbClr val="A4A3A4"/>
          </p15:clr>
        </p15:guide>
        <p15:guide id="2" pos="391" userDrawn="1">
          <p15:clr>
            <a:srgbClr val="A4A3A4"/>
          </p15:clr>
        </p15:guide>
        <p15:guide id="6" orient="horz" pos="6136" userDrawn="1">
          <p15:clr>
            <a:srgbClr val="A4A3A4"/>
          </p15:clr>
        </p15:guide>
        <p15:guide id="7" pos="3884" userDrawn="1">
          <p15:clr>
            <a:srgbClr val="A4A3A4"/>
          </p15:clr>
        </p15:guide>
        <p15:guide id="8" orient="horz" pos="4435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E09670F-CE05-9C7F-2A18-F12607C6DEEE}" name="Eva Herrero Serrano" initials="EHS" userId="S::eh642@cam.ac.uk::30ee73c8-4441-48c1-9b41-6efa0a64ae52" providerId="AD"/>
  <p188:author id="{14A239CE-EE99-779E-A9A8-70BD1B86BCFC}" name="Alex Webb" initials="AW" userId="S::aarw2@cam.ac.uk::6e034127-e0df-4368-bc35-fbdfd215004d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D92"/>
    <a:srgbClr val="163E62"/>
    <a:srgbClr val="4C95D9"/>
    <a:srgbClr val="46B1E1"/>
    <a:srgbClr val="7A81FF"/>
    <a:srgbClr val="0432FF"/>
    <a:srgbClr val="163E63"/>
    <a:srgbClr val="FF8AD8"/>
    <a:srgbClr val="ECECEC"/>
    <a:srgbClr val="4D95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58"/>
  </p:normalViewPr>
  <p:slideViewPr>
    <p:cSldViewPr snapToGrid="0">
      <p:cViewPr varScale="1">
        <p:scale>
          <a:sx n="80" d="100"/>
          <a:sy n="80" d="100"/>
        </p:scale>
        <p:origin x="3576" y="192"/>
      </p:cViewPr>
      <p:guideLst>
        <p:guide orient="horz" pos="1510"/>
        <p:guide pos="391"/>
        <p:guide orient="horz" pos="6136"/>
        <p:guide pos="3884"/>
        <p:guide orient="horz" pos="44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va Herrero Serrano" userId="30ee73c8-4441-48c1-9b41-6efa0a64ae52" providerId="ADAL" clId="{BF4991C5-6BCB-FD43-8051-B8AD91284AEC}"/>
    <pc:docChg chg="delSld">
      <pc:chgData name="Eva Herrero Serrano" userId="30ee73c8-4441-48c1-9b41-6efa0a64ae52" providerId="ADAL" clId="{BF4991C5-6BCB-FD43-8051-B8AD91284AEC}" dt="2025-07-02T13:31:12.620" v="6" actId="2696"/>
      <pc:docMkLst>
        <pc:docMk/>
      </pc:docMkLst>
      <pc:sldChg chg="del">
        <pc:chgData name="Eva Herrero Serrano" userId="30ee73c8-4441-48c1-9b41-6efa0a64ae52" providerId="ADAL" clId="{BF4991C5-6BCB-FD43-8051-B8AD91284AEC}" dt="2025-07-02T13:31:08.595" v="0" actId="2696"/>
        <pc:sldMkLst>
          <pc:docMk/>
          <pc:sldMk cId="328607546" sldId="384"/>
        </pc:sldMkLst>
      </pc:sldChg>
      <pc:sldChg chg="del">
        <pc:chgData name="Eva Herrero Serrano" userId="30ee73c8-4441-48c1-9b41-6efa0a64ae52" providerId="ADAL" clId="{BF4991C5-6BCB-FD43-8051-B8AD91284AEC}" dt="2025-07-02T13:31:12.620" v="6" actId="2696"/>
        <pc:sldMkLst>
          <pc:docMk/>
          <pc:sldMk cId="2380616195" sldId="400"/>
        </pc:sldMkLst>
      </pc:sldChg>
      <pc:sldChg chg="del">
        <pc:chgData name="Eva Herrero Serrano" userId="30ee73c8-4441-48c1-9b41-6efa0a64ae52" providerId="ADAL" clId="{BF4991C5-6BCB-FD43-8051-B8AD91284AEC}" dt="2025-07-02T13:31:08.988" v="1" actId="2696"/>
        <pc:sldMkLst>
          <pc:docMk/>
          <pc:sldMk cId="548085851" sldId="404"/>
        </pc:sldMkLst>
      </pc:sldChg>
      <pc:sldChg chg="del">
        <pc:chgData name="Eva Herrero Serrano" userId="30ee73c8-4441-48c1-9b41-6efa0a64ae52" providerId="ADAL" clId="{BF4991C5-6BCB-FD43-8051-B8AD91284AEC}" dt="2025-07-02T13:31:12.122" v="5" actId="2696"/>
        <pc:sldMkLst>
          <pc:docMk/>
          <pc:sldMk cId="2941851669" sldId="406"/>
        </pc:sldMkLst>
      </pc:sldChg>
      <pc:sldChg chg="del">
        <pc:chgData name="Eva Herrero Serrano" userId="30ee73c8-4441-48c1-9b41-6efa0a64ae52" providerId="ADAL" clId="{BF4991C5-6BCB-FD43-8051-B8AD91284AEC}" dt="2025-07-02T13:31:09.493" v="2" actId="2696"/>
        <pc:sldMkLst>
          <pc:docMk/>
          <pc:sldMk cId="2152653418" sldId="407"/>
        </pc:sldMkLst>
      </pc:sldChg>
      <pc:sldChg chg="del">
        <pc:chgData name="Eva Herrero Serrano" userId="30ee73c8-4441-48c1-9b41-6efa0a64ae52" providerId="ADAL" clId="{BF4991C5-6BCB-FD43-8051-B8AD91284AEC}" dt="2025-07-02T13:31:10.136" v="3" actId="2696"/>
        <pc:sldMkLst>
          <pc:docMk/>
          <pc:sldMk cId="2384589629" sldId="408"/>
        </pc:sldMkLst>
      </pc:sldChg>
      <pc:sldChg chg="del">
        <pc:chgData name="Eva Herrero Serrano" userId="30ee73c8-4441-48c1-9b41-6efa0a64ae52" providerId="ADAL" clId="{BF4991C5-6BCB-FD43-8051-B8AD91284AEC}" dt="2025-07-02T13:31:11.718" v="4" actId="2696"/>
        <pc:sldMkLst>
          <pc:docMk/>
          <pc:sldMk cId="2625866172" sldId="40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3606" cy="3409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5497" y="0"/>
            <a:ext cx="4303606" cy="3409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0B9EA6-4523-204F-A38C-EB310BB9E6E6}" type="datetimeFigureOut">
              <a:rPr lang="en-US" smtClean="0"/>
              <a:t>7/2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171950" y="849313"/>
            <a:ext cx="1587500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3140" y="3269853"/>
            <a:ext cx="7945120" cy="267533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453596"/>
            <a:ext cx="4303606" cy="3409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5497" y="6453596"/>
            <a:ext cx="4303606" cy="3409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B65B47-02A3-6545-81BD-CE096AC3AC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9780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2B65B47-02A3-6545-81BD-CE096AC3AC5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5213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0749-87E1-654D-9347-98A262523D99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366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A369A-2B05-6844-B0A9-E549CABD4D18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881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2C1AE-F068-A54F-BD59-F157D26CAF3B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038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A49AF-D4B1-B841-A3C6-0797BAE97B73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735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EC4B1-A988-4D40-8895-309A5922874F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504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28266-E031-EE4A-AA5B-25E86C1B8835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672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81142-A245-CD4C-98EC-FE91F66445E5}" type="datetime1">
              <a:rPr lang="en-GB" smtClean="0"/>
              <a:t>02/0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482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AF423-F805-2041-97CC-1A4994037567}" type="datetime1">
              <a:rPr lang="en-GB" smtClean="0"/>
              <a:t>02/0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045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91740-F340-7F42-A214-B550E62E5598}" type="datetime1">
              <a:rPr lang="en-GB" smtClean="0"/>
              <a:t>02/0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52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21EBA1-5261-ED4A-BA40-688502E8C4F1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5866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8212F-31D4-CC4E-BBE9-0FE5E46009E3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9610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6F5EBD4-D993-2F4A-BC64-32375B140610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5636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7652DE8-C6FF-904C-60B3-38EEE7959E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1</a:t>
            </a:fld>
            <a:endParaRPr lang="en-US"/>
          </a:p>
        </p:txBody>
      </p:sp>
      <p:pic>
        <p:nvPicPr>
          <p:cNvPr id="7" name="Graphic 6">
            <a:extLst>
              <a:ext uri="{FF2B5EF4-FFF2-40B4-BE49-F238E27FC236}">
                <a16:creationId xmlns:a16="http://schemas.microsoft.com/office/drawing/2014/main" id="{BDC83A06-4F16-7018-704E-9F528FEA07E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 t="65605" b="-707"/>
          <a:stretch/>
        </p:blipFill>
        <p:spPr>
          <a:xfrm>
            <a:off x="440119" y="803071"/>
            <a:ext cx="6096000" cy="172521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F8AA3A0-DD97-968C-8D46-56D8DD3C9134}"/>
              </a:ext>
            </a:extLst>
          </p:cNvPr>
          <p:cNvSpPr txBox="1"/>
          <p:nvPr/>
        </p:nvSpPr>
        <p:spPr>
          <a:xfrm>
            <a:off x="408758" y="2657052"/>
            <a:ext cx="6095999" cy="12576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36000" tIns="36000" rIns="36000" bIns="36000">
            <a:spAutoFit/>
          </a:bodyPr>
          <a:lstStyle/>
          <a:p>
            <a:pPr algn="just"/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Extended data Figure 5. TLWD proteins are present throughout the diel cycle. 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Representative western blots from protein extracts of (A) </a:t>
            </a:r>
            <a:r>
              <a:rPr lang="en-US" sz="1100" i="1">
                <a:latin typeface="Arial" panose="020B0604020202020204" pitchFamily="34" charset="0"/>
                <a:cs typeface="Arial" panose="020B0604020202020204" pitchFamily="34" charset="0"/>
              </a:rPr>
              <a:t>lwd1 lwd2 pLWD1::LWD1-LUC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 and (B</a:t>
            </a:r>
            <a:r>
              <a:rPr lang="en-US" sz="1100" i="1">
                <a:latin typeface="Arial" panose="020B0604020202020204" pitchFamily="34" charset="0"/>
                <a:cs typeface="Arial" panose="020B0604020202020204" pitchFamily="34" charset="0"/>
              </a:rPr>
              <a:t>) ttg1 pTTG1::Venus-TTG1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. Seedlings from two independent lines (Line 1 and Line 2) were grown for 10 days under diel cycles (12hL/12hD) and harvested at the indicated time points. Expected molecular weight for both LWD1-LUC and TTG1-LUC is 100 </a:t>
            </a:r>
            <a:r>
              <a:rPr lang="en-US" sz="110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. Bar graphs shows protein abundance relative to maximum. Ponceau staining shown loading control, 10 µg of protein extract was loaded for each timepoint.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16DD3A9-D684-F927-5383-AE87996BCABA}"/>
              </a:ext>
            </a:extLst>
          </p:cNvPr>
          <p:cNvSpPr txBox="1"/>
          <p:nvPr/>
        </p:nvSpPr>
        <p:spPr>
          <a:xfrm>
            <a:off x="288779" y="688961"/>
            <a:ext cx="415636" cy="338554"/>
          </a:xfrm>
          <a:prstGeom prst="rect">
            <a:avLst/>
          </a:prstGeom>
          <a:noFill/>
        </p:spPr>
        <p:txBody>
          <a:bodyPr wrap="square" lIns="72000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895CCC9-E932-58E2-448A-AB9482071175}"/>
              </a:ext>
            </a:extLst>
          </p:cNvPr>
          <p:cNvSpPr txBox="1"/>
          <p:nvPr/>
        </p:nvSpPr>
        <p:spPr>
          <a:xfrm>
            <a:off x="3555295" y="688961"/>
            <a:ext cx="415636" cy="338554"/>
          </a:xfrm>
          <a:prstGeom prst="rect">
            <a:avLst/>
          </a:prstGeom>
          <a:noFill/>
        </p:spPr>
        <p:txBody>
          <a:bodyPr wrap="square" lIns="72000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8DC2D9A-E5B2-F1BC-6C7D-C356C8283B52}"/>
              </a:ext>
            </a:extLst>
          </p:cNvPr>
          <p:cNvSpPr txBox="1"/>
          <p:nvPr/>
        </p:nvSpPr>
        <p:spPr>
          <a:xfrm>
            <a:off x="381000" y="318219"/>
            <a:ext cx="6095999" cy="241980"/>
          </a:xfrm>
          <a:prstGeom prst="rect">
            <a:avLst/>
          </a:prstGeom>
          <a:noFill/>
          <a:ln>
            <a:noFill/>
          </a:ln>
        </p:spPr>
        <p:txBody>
          <a:bodyPr wrap="square" lIns="36000" tIns="36000" rIns="36000" bIns="36000" anchor="t">
            <a:spAutoFit/>
          </a:bodyPr>
          <a:lstStyle/>
          <a:p>
            <a:pPr algn="just"/>
            <a:r>
              <a:rPr lang="en-US" sz="1100" b="1">
                <a:latin typeface="Arial"/>
                <a:cs typeface="Arial"/>
              </a:rPr>
              <a:t>Extended data Figure 5. TLWD proteins are present throughout the diel cycle</a:t>
            </a:r>
            <a:endParaRPr 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49292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26</Words>
  <Application>Microsoft Macintosh PowerPoint</Application>
  <PresentationFormat>A4 Paper (210x297 mm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va Herrero Serrano</dc:creator>
  <cp:lastModifiedBy>Eva Herrero Serrano</cp:lastModifiedBy>
  <cp:revision>2</cp:revision>
  <cp:lastPrinted>2025-07-02T13:25:36Z</cp:lastPrinted>
  <dcterms:created xsi:type="dcterms:W3CDTF">2024-05-20T09:44:22Z</dcterms:created>
  <dcterms:modified xsi:type="dcterms:W3CDTF">2025-07-02T13:31:14Z</dcterms:modified>
</cp:coreProperties>
</file>